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78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2141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08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9058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7700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6466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9364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170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1715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502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5102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519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043D48-009E-4B16-B81B-629D77D0491D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E42D1-664F-4986-BC7F-262285474D1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673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9600" y="781800"/>
            <a:ext cx="7372800" cy="52944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151423" y="181765"/>
            <a:ext cx="22459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2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15602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238" y="1825625"/>
            <a:ext cx="6059524" cy="4351338"/>
          </a:xfrm>
        </p:spPr>
      </p:pic>
      <p:sp>
        <p:nvSpPr>
          <p:cNvPr id="5" name="矩形 4"/>
          <p:cNvSpPr/>
          <p:nvPr/>
        </p:nvSpPr>
        <p:spPr>
          <a:xfrm>
            <a:off x="1144326" y="1119442"/>
            <a:ext cx="22572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2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700758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238" y="1825625"/>
            <a:ext cx="6059524" cy="4351338"/>
          </a:xfrm>
        </p:spPr>
      </p:pic>
      <p:sp>
        <p:nvSpPr>
          <p:cNvPr id="5" name="矩形 4"/>
          <p:cNvSpPr/>
          <p:nvPr/>
        </p:nvSpPr>
        <p:spPr>
          <a:xfrm>
            <a:off x="996280" y="1204159"/>
            <a:ext cx="22572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2</a:t>
            </a:r>
            <a:r>
              <a:rPr lang="en-US" altLang="zh-CN" dirty="0" smtClean="0"/>
              <a:t>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055688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6238" y="1825625"/>
            <a:ext cx="6059524" cy="4351338"/>
          </a:xfrm>
        </p:spPr>
      </p:pic>
      <p:sp>
        <p:nvSpPr>
          <p:cNvPr id="5" name="矩形 4"/>
          <p:cNvSpPr/>
          <p:nvPr/>
        </p:nvSpPr>
        <p:spPr>
          <a:xfrm>
            <a:off x="1039823" y="1204159"/>
            <a:ext cx="22572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2</a:t>
            </a:r>
            <a:r>
              <a:rPr lang="en-US" altLang="zh-CN" dirty="0" smtClean="0"/>
              <a:t>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624858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5408" y="1825625"/>
            <a:ext cx="5041183" cy="4351338"/>
          </a:xfrm>
        </p:spPr>
      </p:pic>
      <p:sp>
        <p:nvSpPr>
          <p:cNvPr id="5" name="矩形 4"/>
          <p:cNvSpPr/>
          <p:nvPr/>
        </p:nvSpPr>
        <p:spPr>
          <a:xfrm>
            <a:off x="1065949" y="1204159"/>
            <a:ext cx="22572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2</a:t>
            </a:r>
            <a:r>
              <a:rPr lang="en-US" altLang="zh-CN" dirty="0" smtClean="0"/>
              <a:t>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727582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175" y="1920273"/>
            <a:ext cx="2696665" cy="2420328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0884" y="1920273"/>
            <a:ext cx="2696665" cy="242032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6205" y="1920273"/>
            <a:ext cx="2696665" cy="242032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04969" y="1941750"/>
            <a:ext cx="2696665" cy="2420328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4060328" y="4959923"/>
            <a:ext cx="23293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Source Data-Figure </a:t>
            </a:r>
            <a:r>
              <a:rPr lang="zh-CN" altLang="en-US" dirty="0" smtClean="0"/>
              <a:t>2</a:t>
            </a:r>
            <a:r>
              <a:rPr lang="en-US" altLang="zh-CN" dirty="0" smtClean="0"/>
              <a:t>f-</a:t>
            </a:r>
            <a:r>
              <a:rPr lang="en-US" altLang="zh-CN" dirty="0" err="1" smtClean="0"/>
              <a:t>i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28606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6</Words>
  <Application>Microsoft Office PowerPoint</Application>
  <PresentationFormat>宽屏</PresentationFormat>
  <Paragraphs>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霞</dc:creator>
  <cp:lastModifiedBy>王 霞</cp:lastModifiedBy>
  <cp:revision>2</cp:revision>
  <dcterms:created xsi:type="dcterms:W3CDTF">2018-11-11T13:45:35Z</dcterms:created>
  <dcterms:modified xsi:type="dcterms:W3CDTF">2018-12-08T12:54:58Z</dcterms:modified>
</cp:coreProperties>
</file>